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7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317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B973BA-F358-4978-8DA7-1922D0574E82}" type="datetimeFigureOut">
              <a:rPr lang="ru-RU" smtClean="0"/>
              <a:t>10.08.2025</a:t>
            </a:fld>
            <a:endParaRPr lang="ru-R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2F3B3D-0520-4C52-93B1-D3F26DF1E967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078005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2F3B3D-0520-4C52-93B1-D3F26DF1E967}" type="slidenum">
              <a:rPr lang="ru-RU" smtClean="0"/>
              <a:t>1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69179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5BFE1-205C-4455-A7BE-B949CDB75E1F}" type="datetimeFigureOut">
              <a:rPr lang="ru-RU" smtClean="0"/>
              <a:t>10.08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3455-F2A3-4817-80BC-51772221B31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02420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5BFE1-205C-4455-A7BE-B949CDB75E1F}" type="datetimeFigureOut">
              <a:rPr lang="ru-RU" smtClean="0"/>
              <a:t>10.08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3455-F2A3-4817-80BC-51772221B31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92851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5BFE1-205C-4455-A7BE-B949CDB75E1F}" type="datetimeFigureOut">
              <a:rPr lang="ru-RU" smtClean="0"/>
              <a:t>10.08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3455-F2A3-4817-80BC-51772221B31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58853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5BFE1-205C-4455-A7BE-B949CDB75E1F}" type="datetimeFigureOut">
              <a:rPr lang="ru-RU" smtClean="0"/>
              <a:t>10.08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3455-F2A3-4817-80BC-51772221B31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89278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5BFE1-205C-4455-A7BE-B949CDB75E1F}" type="datetimeFigureOut">
              <a:rPr lang="ru-RU" smtClean="0"/>
              <a:t>10.08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3455-F2A3-4817-80BC-51772221B31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73410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5BFE1-205C-4455-A7BE-B949CDB75E1F}" type="datetimeFigureOut">
              <a:rPr lang="ru-RU" smtClean="0"/>
              <a:t>10.08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3455-F2A3-4817-80BC-51772221B31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23235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5BFE1-205C-4455-A7BE-B949CDB75E1F}" type="datetimeFigureOut">
              <a:rPr lang="ru-RU" smtClean="0"/>
              <a:t>10.08.2025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3455-F2A3-4817-80BC-51772221B31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54994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5BFE1-205C-4455-A7BE-B949CDB75E1F}" type="datetimeFigureOut">
              <a:rPr lang="ru-RU" smtClean="0"/>
              <a:t>10.08.2025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3455-F2A3-4817-80BC-51772221B31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732001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5BFE1-205C-4455-A7BE-B949CDB75E1F}" type="datetimeFigureOut">
              <a:rPr lang="ru-RU" smtClean="0"/>
              <a:t>10.08.2025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3455-F2A3-4817-80BC-51772221B31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106790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5BFE1-205C-4455-A7BE-B949CDB75E1F}" type="datetimeFigureOut">
              <a:rPr lang="ru-RU" smtClean="0"/>
              <a:t>10.08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3455-F2A3-4817-80BC-51772221B31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35152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B5BFE1-205C-4455-A7BE-B949CDB75E1F}" type="datetimeFigureOut">
              <a:rPr lang="ru-RU" smtClean="0"/>
              <a:t>10.08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3455-F2A3-4817-80BC-51772221B31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59805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B5BFE1-205C-4455-A7BE-B949CDB75E1F}" type="datetimeFigureOut">
              <a:rPr lang="ru-RU" smtClean="0"/>
              <a:t>10.08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743455-F2A3-4817-80BC-51772221B31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66344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>
            <a:extLst>
              <a:ext uri="{FF2B5EF4-FFF2-40B4-BE49-F238E27FC236}">
                <a16:creationId xmlns:a16="http://schemas.microsoft.com/office/drawing/2014/main" id="{1B3E9404-E32D-014C-5071-6B69994BB3AB}"/>
              </a:ext>
            </a:extLst>
          </p:cNvPr>
          <p:cNvGrpSpPr/>
          <p:nvPr/>
        </p:nvGrpSpPr>
        <p:grpSpPr>
          <a:xfrm>
            <a:off x="1159151" y="757429"/>
            <a:ext cx="4882598" cy="4825233"/>
            <a:chOff x="1159151" y="757429"/>
            <a:chExt cx="4882598" cy="4825233"/>
          </a:xfrm>
        </p:grpSpPr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77AAB3E9-E404-45BF-94D2-ABE9A9A2DC05}"/>
                </a:ext>
              </a:extLst>
            </p:cNvPr>
            <p:cNvGrpSpPr/>
            <p:nvPr/>
          </p:nvGrpSpPr>
          <p:grpSpPr>
            <a:xfrm>
              <a:off x="1159151" y="757429"/>
              <a:ext cx="4882598" cy="4825233"/>
              <a:chOff x="1052449" y="3551429"/>
              <a:chExt cx="4882598" cy="4825233"/>
            </a:xfrm>
          </p:grpSpPr>
          <p:pic>
            <p:nvPicPr>
              <p:cNvPr id="5" name="Рисунок 1">
                <a:extLst>
                  <a:ext uri="{FF2B5EF4-FFF2-40B4-BE49-F238E27FC236}">
                    <a16:creationId xmlns:a16="http://schemas.microsoft.com/office/drawing/2014/main" id="{D42DFE5F-0915-9FA9-E9F8-8780B1BD45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1393" t="9815" r="10316" b="9403"/>
              <a:stretch/>
            </p:blipFill>
            <p:spPr>
              <a:xfrm>
                <a:off x="1718695" y="3551429"/>
                <a:ext cx="4081884" cy="2100744"/>
              </a:xfrm>
              <a:prstGeom prst="rect">
                <a:avLst/>
              </a:prstGeom>
            </p:spPr>
          </p:pic>
          <p:pic>
            <p:nvPicPr>
              <p:cNvPr id="6" name="Рисунок 1">
                <a:extLst>
                  <a:ext uri="{FF2B5EF4-FFF2-40B4-BE49-F238E27FC236}">
                    <a16:creationId xmlns:a16="http://schemas.microsoft.com/office/drawing/2014/main" id="{6316C88D-C4B8-1FF6-5486-8057C27B4CE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92150" t="7149" r="2840" b="5202"/>
              <a:stretch/>
            </p:blipFill>
            <p:spPr>
              <a:xfrm>
                <a:off x="1052449" y="3551429"/>
                <a:ext cx="490308" cy="4825233"/>
              </a:xfrm>
              <a:prstGeom prst="rect">
                <a:avLst/>
              </a:prstGeom>
            </p:spPr>
          </p:pic>
          <p:pic>
            <p:nvPicPr>
              <p:cNvPr id="8" name="Рисунок 3">
                <a:extLst>
                  <a:ext uri="{FF2B5EF4-FFF2-40B4-BE49-F238E27FC236}">
                    <a16:creationId xmlns:a16="http://schemas.microsoft.com/office/drawing/2014/main" id="{811825B3-37F7-A1E5-5DF6-04628B3F51F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1299" t="9370" r="57538" b="9430"/>
              <a:stretch/>
            </p:blipFill>
            <p:spPr>
              <a:xfrm>
                <a:off x="1854679" y="6306967"/>
                <a:ext cx="1710305" cy="2002309"/>
              </a:xfrm>
              <a:prstGeom prst="rect">
                <a:avLst/>
              </a:prstGeom>
            </p:spPr>
          </p:pic>
          <p:pic>
            <p:nvPicPr>
              <p:cNvPr id="9" name="Рисунок 4">
                <a:extLst>
                  <a:ext uri="{FF2B5EF4-FFF2-40B4-BE49-F238E27FC236}">
                    <a16:creationId xmlns:a16="http://schemas.microsoft.com/office/drawing/2014/main" id="{6A15C7B0-C1E5-DFAD-D075-987754FC173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1436" t="9613" r="59658" b="9104"/>
              <a:stretch/>
            </p:blipFill>
            <p:spPr>
              <a:xfrm>
                <a:off x="4231230" y="6306967"/>
                <a:ext cx="1703817" cy="2002309"/>
              </a:xfrm>
              <a:prstGeom prst="rect">
                <a:avLst/>
              </a:prstGeom>
            </p:spPr>
          </p:pic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A6C4608B-1ED1-5AD2-ED4F-F743215F3C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77274" y="3551429"/>
                <a:ext cx="0" cy="2135468"/>
              </a:xfrm>
              <a:prstGeom prst="line">
                <a:avLst/>
              </a:prstGeom>
              <a:ln w="12700">
                <a:solidFill>
                  <a:schemeClr val="bg2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9F3B13BF-4A14-5148-BEDC-72EACE5977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29674" y="3551429"/>
                <a:ext cx="0" cy="2135468"/>
              </a:xfrm>
              <a:prstGeom prst="line">
                <a:avLst/>
              </a:prstGeom>
              <a:ln w="12700">
                <a:solidFill>
                  <a:schemeClr val="bg2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05B2D074-6A5A-5952-44A0-B9362AA9280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854679" y="5686896"/>
                <a:ext cx="2422595" cy="577916"/>
              </a:xfrm>
              <a:prstGeom prst="line">
                <a:avLst/>
              </a:prstGeom>
              <a:ln w="12700">
                <a:solidFill>
                  <a:schemeClr val="bg2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C5D0BD44-54CB-1B36-2D3B-51E390A0255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564984" y="5686896"/>
                <a:ext cx="873565" cy="620071"/>
              </a:xfrm>
              <a:prstGeom prst="line">
                <a:avLst/>
              </a:prstGeom>
              <a:ln w="12700">
                <a:solidFill>
                  <a:schemeClr val="bg2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B2B0E2D5-F59E-BC63-F76F-387B18A5B3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21995" y="3558860"/>
                <a:ext cx="0" cy="2135468"/>
              </a:xfrm>
              <a:prstGeom prst="line">
                <a:avLst/>
              </a:prstGeom>
              <a:ln w="12700">
                <a:solidFill>
                  <a:schemeClr val="bg2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AB31BC85-21E4-AFA9-C670-0DE71FB321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74395" y="3558860"/>
                <a:ext cx="0" cy="2135468"/>
              </a:xfrm>
              <a:prstGeom prst="line">
                <a:avLst/>
              </a:prstGeom>
              <a:ln w="12700">
                <a:solidFill>
                  <a:schemeClr val="bg2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C58986E4-569A-0FD4-BD32-D3620AB0276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31230" y="5694327"/>
                <a:ext cx="1103465" cy="605208"/>
              </a:xfrm>
              <a:prstGeom prst="line">
                <a:avLst/>
              </a:prstGeom>
              <a:ln w="12700">
                <a:solidFill>
                  <a:schemeClr val="bg2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0AD1A899-C53E-7005-8B01-46838734FA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95970" y="5694327"/>
                <a:ext cx="439077" cy="570485"/>
              </a:xfrm>
              <a:prstGeom prst="line">
                <a:avLst/>
              </a:prstGeom>
              <a:ln w="12700">
                <a:solidFill>
                  <a:schemeClr val="bg2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F437AA0D-61A8-0675-F0A7-E7D68D2A10D2}"/>
                </a:ext>
              </a:extLst>
            </p:cNvPr>
            <p:cNvSpPr txBox="1"/>
            <p:nvPr/>
          </p:nvSpPr>
          <p:spPr>
            <a:xfrm>
              <a:off x="1649459" y="5357376"/>
              <a:ext cx="39305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hg17</a:t>
              </a:r>
              <a:endParaRPr lang="ru-RU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D90A00B2-04C6-06AB-9224-E981B9F4DE7F}"/>
              </a:ext>
            </a:extLst>
          </p:cNvPr>
          <p:cNvSpPr txBox="1"/>
          <p:nvPr/>
        </p:nvSpPr>
        <p:spPr>
          <a:xfrm>
            <a:off x="654050" y="6393034"/>
            <a:ext cx="5765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S1 Localization of breakpoints o 1q gain in the P16L2 cell line revealed by SNP arrays. </a:t>
            </a:r>
            <a:endParaRPr lang="ru-RU" sz="1200" dirty="0"/>
          </a:p>
        </p:txBody>
      </p:sp>
    </p:spTree>
    <p:extLst>
      <p:ext uri="{BB962C8B-B14F-4D97-AF65-F5344CB8AC3E}">
        <p14:creationId xmlns:p14="http://schemas.microsoft.com/office/powerpoint/2010/main" val="22886193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7">
            <a:extLst>
              <a:ext uri="{FF2B5EF4-FFF2-40B4-BE49-F238E27FC236}">
                <a16:creationId xmlns:a16="http://schemas.microsoft.com/office/drawing/2014/main" id="{640CA359-8F65-6E2B-7845-2FD55CB85A24}"/>
              </a:ext>
            </a:extLst>
          </p:cNvPr>
          <p:cNvGrpSpPr/>
          <p:nvPr/>
        </p:nvGrpSpPr>
        <p:grpSpPr>
          <a:xfrm>
            <a:off x="411536" y="917437"/>
            <a:ext cx="6034927" cy="5754984"/>
            <a:chOff x="373217" y="2825750"/>
            <a:chExt cx="6034927" cy="5754984"/>
          </a:xfrm>
        </p:grpSpPr>
        <p:pic>
          <p:nvPicPr>
            <p:cNvPr id="4" name="Рисунок 2">
              <a:extLst>
                <a:ext uri="{FF2B5EF4-FFF2-40B4-BE49-F238E27FC236}">
                  <a16:creationId xmlns:a16="http://schemas.microsoft.com/office/drawing/2014/main" id="{4A4078BF-9846-F981-557E-F1A9EC5B743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1747" t="37533" r="10136" b="15792"/>
            <a:stretch/>
          </p:blipFill>
          <p:spPr>
            <a:xfrm>
              <a:off x="3549650" y="4290216"/>
              <a:ext cx="2858494" cy="1028907"/>
            </a:xfrm>
            <a:prstGeom prst="rect">
              <a:avLst/>
            </a:prstGeom>
            <a:ln>
              <a:solidFill>
                <a:schemeClr val="bg2">
                  <a:lumMod val="75000"/>
                </a:schemeClr>
              </a:solidFill>
            </a:ln>
          </p:spPr>
        </p:pic>
        <p:pic>
          <p:nvPicPr>
            <p:cNvPr id="5" name="Рисунок 2">
              <a:extLst>
                <a:ext uri="{FF2B5EF4-FFF2-40B4-BE49-F238E27FC236}">
                  <a16:creationId xmlns:a16="http://schemas.microsoft.com/office/drawing/2014/main" id="{9C4D6DFA-82F6-C4AB-ACA4-77B35AFE9FE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1747" t="8980" r="10136" b="64903"/>
            <a:stretch/>
          </p:blipFill>
          <p:spPr>
            <a:xfrm>
              <a:off x="763850" y="2825750"/>
              <a:ext cx="5471075" cy="1028907"/>
            </a:xfrm>
            <a:prstGeom prst="rect">
              <a:avLst/>
            </a:prstGeom>
          </p:spPr>
        </p:pic>
        <p:pic>
          <p:nvPicPr>
            <p:cNvPr id="6" name="Рисунок 1">
              <a:extLst>
                <a:ext uri="{FF2B5EF4-FFF2-40B4-BE49-F238E27FC236}">
                  <a16:creationId xmlns:a16="http://schemas.microsoft.com/office/drawing/2014/main" id="{A47FC46C-536F-2FA6-88BD-E11C80D2E79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1584" t="37297" r="10479" b="13127"/>
            <a:stretch/>
          </p:blipFill>
          <p:spPr>
            <a:xfrm>
              <a:off x="373217" y="4290216"/>
              <a:ext cx="3039577" cy="1028907"/>
            </a:xfrm>
            <a:prstGeom prst="rect">
              <a:avLst/>
            </a:prstGeom>
            <a:ln>
              <a:solidFill>
                <a:schemeClr val="bg2">
                  <a:lumMod val="75000"/>
                </a:schemeClr>
              </a:solidFill>
            </a:ln>
          </p:spPr>
        </p:pic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D7B7A350-B52E-F7AF-6D53-A6183163760E}"/>
                </a:ext>
              </a:extLst>
            </p:cNvPr>
            <p:cNvCxnSpPr>
              <a:cxnSpLocks/>
            </p:cNvCxnSpPr>
            <p:nvPr/>
          </p:nvCxnSpPr>
          <p:spPr>
            <a:xfrm>
              <a:off x="1060450" y="3460750"/>
              <a:ext cx="0" cy="77470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394E8512-E02A-74EF-5D7E-2D4724D67F6C}"/>
                </a:ext>
              </a:extLst>
            </p:cNvPr>
            <p:cNvCxnSpPr>
              <a:cxnSpLocks/>
            </p:cNvCxnSpPr>
            <p:nvPr/>
          </p:nvCxnSpPr>
          <p:spPr>
            <a:xfrm>
              <a:off x="3308350" y="3848100"/>
              <a:ext cx="768350" cy="31115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3" name="Рисунок 3">
              <a:extLst>
                <a:ext uri="{FF2B5EF4-FFF2-40B4-BE49-F238E27FC236}">
                  <a16:creationId xmlns:a16="http://schemas.microsoft.com/office/drawing/2014/main" id="{FF4C9754-C309-362D-C8C3-DADA29BDD31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1758" t="13622" r="67131" b="8683"/>
            <a:stretch/>
          </p:blipFill>
          <p:spPr>
            <a:xfrm>
              <a:off x="882712" y="5808073"/>
              <a:ext cx="1790699" cy="2515506"/>
            </a:xfrm>
            <a:prstGeom prst="rect">
              <a:avLst/>
            </a:prstGeom>
          </p:spPr>
        </p:pic>
        <p:pic>
          <p:nvPicPr>
            <p:cNvPr id="14" name="Рисунок 4">
              <a:extLst>
                <a:ext uri="{FF2B5EF4-FFF2-40B4-BE49-F238E27FC236}">
                  <a16:creationId xmlns:a16="http://schemas.microsoft.com/office/drawing/2014/main" id="{23016316-FED1-713C-2690-0A7F2C4ED22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1455" t="13223" r="59769" b="8847"/>
            <a:stretch/>
          </p:blipFill>
          <p:spPr>
            <a:xfrm>
              <a:off x="3715141" y="5808073"/>
              <a:ext cx="2218156" cy="2507575"/>
            </a:xfrm>
            <a:prstGeom prst="rect">
              <a:avLst/>
            </a:prstGeom>
          </p:spPr>
        </p:pic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5332A644-BD74-2A0A-A752-99F2D71D259C}"/>
                </a:ext>
              </a:extLst>
            </p:cNvPr>
            <p:cNvCxnSpPr>
              <a:cxnSpLocks/>
            </p:cNvCxnSpPr>
            <p:nvPr/>
          </p:nvCxnSpPr>
          <p:spPr>
            <a:xfrm>
              <a:off x="2166315" y="4290216"/>
              <a:ext cx="0" cy="1180773"/>
            </a:xfrm>
            <a:prstGeom prst="line">
              <a:avLst/>
            </a:prstGeom>
            <a:ln w="12700">
              <a:solidFill>
                <a:schemeClr val="bg2">
                  <a:lumMod val="50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90409D15-93FA-F0A7-1ED0-7E6CB4123E9F}"/>
                </a:ext>
              </a:extLst>
            </p:cNvPr>
            <p:cNvCxnSpPr>
              <a:cxnSpLocks/>
            </p:cNvCxnSpPr>
            <p:nvPr/>
          </p:nvCxnSpPr>
          <p:spPr>
            <a:xfrm>
              <a:off x="2318715" y="4290216"/>
              <a:ext cx="0" cy="1180773"/>
            </a:xfrm>
            <a:prstGeom prst="line">
              <a:avLst/>
            </a:prstGeom>
            <a:ln w="12700">
              <a:solidFill>
                <a:schemeClr val="bg2">
                  <a:lumMod val="50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8C7FBA46-C51B-D955-7BE5-605DF84C34A9}"/>
                </a:ext>
              </a:extLst>
            </p:cNvPr>
            <p:cNvCxnSpPr>
              <a:cxnSpLocks/>
            </p:cNvCxnSpPr>
            <p:nvPr/>
          </p:nvCxnSpPr>
          <p:spPr>
            <a:xfrm>
              <a:off x="4404368" y="4290215"/>
              <a:ext cx="0" cy="1180773"/>
            </a:xfrm>
            <a:prstGeom prst="line">
              <a:avLst/>
            </a:prstGeom>
            <a:ln w="12700">
              <a:solidFill>
                <a:schemeClr val="bg2">
                  <a:lumMod val="50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9D47C3B2-90A0-F3FE-2791-E4AB907D425A}"/>
                </a:ext>
              </a:extLst>
            </p:cNvPr>
            <p:cNvCxnSpPr>
              <a:cxnSpLocks/>
            </p:cNvCxnSpPr>
            <p:nvPr/>
          </p:nvCxnSpPr>
          <p:spPr>
            <a:xfrm>
              <a:off x="4556768" y="4290215"/>
              <a:ext cx="0" cy="1180773"/>
            </a:xfrm>
            <a:prstGeom prst="line">
              <a:avLst/>
            </a:prstGeom>
            <a:ln w="12700">
              <a:solidFill>
                <a:schemeClr val="bg2">
                  <a:lumMod val="50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0B769C70-A169-00CA-46E0-9FBB302B4D3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2712" y="5470988"/>
              <a:ext cx="1283603" cy="337085"/>
            </a:xfrm>
            <a:prstGeom prst="line">
              <a:avLst/>
            </a:prstGeom>
            <a:ln w="12700">
              <a:solidFill>
                <a:schemeClr val="bg2">
                  <a:lumMod val="50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8BB6250C-B58C-DDF1-E7A2-AE8504A21EAF}"/>
                </a:ext>
              </a:extLst>
            </p:cNvPr>
            <p:cNvCxnSpPr>
              <a:cxnSpLocks/>
            </p:cNvCxnSpPr>
            <p:nvPr/>
          </p:nvCxnSpPr>
          <p:spPr>
            <a:xfrm>
              <a:off x="2327590" y="5470988"/>
              <a:ext cx="307731" cy="283694"/>
            </a:xfrm>
            <a:prstGeom prst="line">
              <a:avLst/>
            </a:prstGeom>
            <a:ln w="12700">
              <a:solidFill>
                <a:schemeClr val="bg2">
                  <a:lumMod val="50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87F8C41A-B504-028F-D01A-BD3EBF6ACFF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15141" y="5470988"/>
              <a:ext cx="689227" cy="337085"/>
            </a:xfrm>
            <a:prstGeom prst="line">
              <a:avLst/>
            </a:prstGeom>
            <a:ln w="12700">
              <a:solidFill>
                <a:schemeClr val="bg2">
                  <a:lumMod val="50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4CF8D7A2-E925-4DD8-65C7-5D204974FFF2}"/>
                </a:ext>
              </a:extLst>
            </p:cNvPr>
            <p:cNvCxnSpPr>
              <a:cxnSpLocks/>
            </p:cNvCxnSpPr>
            <p:nvPr/>
          </p:nvCxnSpPr>
          <p:spPr>
            <a:xfrm>
              <a:off x="4556768" y="5470988"/>
              <a:ext cx="1376529" cy="283694"/>
            </a:xfrm>
            <a:prstGeom prst="line">
              <a:avLst/>
            </a:prstGeom>
            <a:ln w="12700">
              <a:solidFill>
                <a:schemeClr val="bg2">
                  <a:lumMod val="50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5B427C56-73AA-1736-A78E-2FEFCD207756}"/>
                </a:ext>
              </a:extLst>
            </p:cNvPr>
            <p:cNvSpPr/>
            <p:nvPr/>
          </p:nvSpPr>
          <p:spPr>
            <a:xfrm>
              <a:off x="1361326" y="5797799"/>
              <a:ext cx="148976" cy="271434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B9688C96-114F-B07A-714C-A63236DF166E}"/>
                </a:ext>
              </a:extLst>
            </p:cNvPr>
            <p:cNvSpPr/>
            <p:nvPr/>
          </p:nvSpPr>
          <p:spPr>
            <a:xfrm>
              <a:off x="4815469" y="5797799"/>
              <a:ext cx="896962" cy="271434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E7D1F50-5FE1-59A7-3D17-5ADF91FB1299}"/>
                </a:ext>
              </a:extLst>
            </p:cNvPr>
            <p:cNvSpPr txBox="1"/>
            <p:nvPr/>
          </p:nvSpPr>
          <p:spPr>
            <a:xfrm>
              <a:off x="5075437" y="8303831"/>
              <a:ext cx="4635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DCC</a:t>
              </a:r>
              <a:endParaRPr lang="ru-RU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AAC90CC-342A-0C8E-7C79-4A122E55AA18}"/>
                </a:ext>
              </a:extLst>
            </p:cNvPr>
            <p:cNvSpPr txBox="1"/>
            <p:nvPr/>
          </p:nvSpPr>
          <p:spPr>
            <a:xfrm>
              <a:off x="1449912" y="8334513"/>
              <a:ext cx="10005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IST2 cluster</a:t>
              </a:r>
              <a:endParaRPr lang="ru-R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7585CDD-9C61-F451-E472-4E9BB144D11C}"/>
                </a:ext>
              </a:extLst>
            </p:cNvPr>
            <p:cNvSpPr txBox="1"/>
            <p:nvPr/>
          </p:nvSpPr>
          <p:spPr>
            <a:xfrm>
              <a:off x="531647" y="8075197"/>
              <a:ext cx="39305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hg17</a:t>
              </a:r>
              <a:endParaRPr lang="ru-RU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244CF945-38A5-E74A-B0A9-D80CF270F992}"/>
                </a:ext>
              </a:extLst>
            </p:cNvPr>
            <p:cNvSpPr txBox="1"/>
            <p:nvPr/>
          </p:nvSpPr>
          <p:spPr>
            <a:xfrm>
              <a:off x="3380683" y="8095434"/>
              <a:ext cx="39305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hg17</a:t>
              </a:r>
              <a:endParaRPr lang="ru-RU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7C329F5F-C30D-78C3-61DA-C40D5AEF519C}"/>
              </a:ext>
            </a:extLst>
          </p:cNvPr>
          <p:cNvSpPr txBox="1"/>
          <p:nvPr/>
        </p:nvSpPr>
        <p:spPr>
          <a:xfrm>
            <a:off x="654806" y="6930637"/>
            <a:ext cx="5765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</a:t>
            </a:r>
            <a:r>
              <a:rPr lang="en-US" sz="1200"/>
              <a:t>Figure S2 </a:t>
            </a:r>
            <a:r>
              <a:rPr lang="en-US" sz="1200" dirty="0"/>
              <a:t>Localization of breakpoints o 1q gain/18q loss (unbalanced translocation) in the HAS cell line revealed by SNP arrays. </a:t>
            </a:r>
            <a:endParaRPr lang="ru-RU" sz="1200" dirty="0"/>
          </a:p>
        </p:txBody>
      </p:sp>
    </p:spTree>
    <p:extLst>
      <p:ext uri="{BB962C8B-B14F-4D97-AF65-F5344CB8AC3E}">
        <p14:creationId xmlns:p14="http://schemas.microsoft.com/office/powerpoint/2010/main" val="2734526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99</TotalTime>
  <Words>52</Words>
  <Application>Microsoft Office PowerPoint</Application>
  <PresentationFormat>A4 Paper (210x297 mm)</PresentationFormat>
  <Paragraphs>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na Zheglo</dc:creator>
  <cp:lastModifiedBy>MDPI</cp:lastModifiedBy>
  <cp:revision>3</cp:revision>
  <dcterms:created xsi:type="dcterms:W3CDTF">2025-07-28T04:30:18Z</dcterms:created>
  <dcterms:modified xsi:type="dcterms:W3CDTF">2025-08-10T06:45:51Z</dcterms:modified>
</cp:coreProperties>
</file>